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Figure 1" id="{161F49DA-CE53-E54C-924C-D3751C2C019B}">
          <p14:sldIdLst>
            <p14:sldId id="256"/>
          </p14:sldIdLst>
        </p14:section>
        <p14:section name="Supplementary Figure 2" id="{EFC078AD-E4A6-DA4A-8279-F6FF1DDE96C4}">
          <p14:sldIdLst>
            <p14:sldId id="257"/>
            <p14:sldId id="258"/>
          </p14:sldIdLst>
        </p14:section>
        <p14:section name="Supplementary Figure 2" id="{602B0A2A-6787-D640-85CD-9D212AC2D259}">
          <p14:sldIdLst>
            <p14:sldId id="25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91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71"/>
    <p:restoredTop sz="97840"/>
  </p:normalViewPr>
  <p:slideViewPr>
    <p:cSldViewPr snapToGrid="0" showGuides="1">
      <p:cViewPr varScale="1">
        <p:scale>
          <a:sx n="86" d="100"/>
          <a:sy n="86" d="100"/>
        </p:scale>
        <p:origin x="4016" y="200"/>
      </p:cViewPr>
      <p:guideLst>
        <p:guide orient="horz" pos="291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a-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1"/>
            <c:plus>
              <c:numRef>
                <c:f>Sheet1!$E$2:$E$3</c:f>
                <c:numCache>
                  <c:formatCode>General</c:formatCode>
                  <c:ptCount val="2"/>
                  <c:pt idx="0">
                    <c:v>9.11</c:v>
                  </c:pt>
                  <c:pt idx="1">
                    <c:v>5.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65.069999999999993</c:v>
                </c:pt>
                <c:pt idx="1">
                  <c:v>44.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96-A54C-969B-F24F2D92E30F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psi-</c:v>
                </c:pt>
              </c:strCache>
            </c:strRef>
          </c:tx>
          <c:spPr>
            <a:solidFill>
              <a:srgbClr val="E63A3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7679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C62-5442-B9DF-0407B0B4E3BA}"/>
              </c:ext>
            </c:extLst>
          </c:dPt>
          <c:errBars>
            <c:errBarType val="plus"/>
            <c:errValType val="cust"/>
            <c:noEndCap val="1"/>
            <c:plus>
              <c:numRef>
                <c:f>Sheet1!$F$2:$F$3</c:f>
                <c:numCache>
                  <c:formatCode>General</c:formatCode>
                  <c:ptCount val="2"/>
                  <c:pt idx="0">
                    <c:v>10.67</c:v>
                  </c:pt>
                  <c:pt idx="1">
                    <c:v>4.440000000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78.540000000000006</c:v>
                </c:pt>
                <c:pt idx="1">
                  <c:v>49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A96-A54C-969B-F24F2D92E3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874448"/>
        <c:axId val="-2138911360"/>
      </c:barChart>
      <c:catAx>
        <c:axId val="-2138874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spc="-15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911360"/>
        <c:crosses val="autoZero"/>
        <c:auto val="1"/>
        <c:lblAlgn val="ctr"/>
        <c:lblOffset val="100"/>
        <c:noMultiLvlLbl val="0"/>
      </c:catAx>
      <c:valAx>
        <c:axId val="-213891136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87444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a-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1"/>
            <c:plus>
              <c:numRef>
                <c:f>Sheet1!$E$2:$E$3</c:f>
                <c:numCache>
                  <c:formatCode>General</c:formatCode>
                  <c:ptCount val="2"/>
                  <c:pt idx="0">
                    <c:v>49.76</c:v>
                  </c:pt>
                  <c:pt idx="1">
                    <c:v>62.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238.3</c:v>
                </c:pt>
                <c:pt idx="1">
                  <c:v>321.1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05-1D47-807B-FB4FF89776E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psi-</c:v>
                </c:pt>
              </c:strCache>
            </c:strRef>
          </c:tx>
          <c:spPr>
            <a:solidFill>
              <a:srgbClr val="E63A3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7679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705-1D47-807B-FB4FF89776E5}"/>
              </c:ext>
            </c:extLst>
          </c:dPt>
          <c:errBars>
            <c:errBarType val="plus"/>
            <c:errValType val="cust"/>
            <c:noEndCap val="1"/>
            <c:plus>
              <c:numRef>
                <c:f>Sheet1!$F$2:$F$3</c:f>
                <c:numCache>
                  <c:formatCode>General</c:formatCode>
                  <c:ptCount val="2"/>
                  <c:pt idx="0">
                    <c:v>27.76</c:v>
                  </c:pt>
                  <c:pt idx="1">
                    <c:v>21.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192.54</c:v>
                </c:pt>
                <c:pt idx="1">
                  <c:v>262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05-1D47-807B-FB4FF89776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874448"/>
        <c:axId val="-2138911360"/>
      </c:barChart>
      <c:catAx>
        <c:axId val="-2138874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spc="-15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911360"/>
        <c:crosses val="autoZero"/>
        <c:auto val="1"/>
        <c:lblAlgn val="ctr"/>
        <c:lblOffset val="100"/>
        <c:noMultiLvlLbl val="0"/>
      </c:catAx>
      <c:valAx>
        <c:axId val="-2138911360"/>
        <c:scaling>
          <c:orientation val="minMax"/>
          <c:max val="4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87444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a-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1"/>
            <c:plus>
              <c:numRef>
                <c:f>Sheet1!$E$2:$E$3</c:f>
                <c:numCache>
                  <c:formatCode>General</c:formatCode>
                  <c:ptCount val="2"/>
                  <c:pt idx="0">
                    <c:v>9.11</c:v>
                  </c:pt>
                  <c:pt idx="1">
                    <c:v>8.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65.069999999999993</c:v>
                </c:pt>
                <c:pt idx="1">
                  <c:v>65.06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49-7C46-A070-92FE41EBD6DF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psi-</c:v>
                </c:pt>
              </c:strCache>
            </c:strRef>
          </c:tx>
          <c:spPr>
            <a:solidFill>
              <a:srgbClr val="E63A3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7679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0E49-7C46-A070-92FE41EBD6DF}"/>
              </c:ext>
            </c:extLst>
          </c:dPt>
          <c:errBars>
            <c:errBarType val="plus"/>
            <c:errValType val="cust"/>
            <c:noEndCap val="1"/>
            <c:plus>
              <c:numRef>
                <c:f>Sheet1!$F$2:$F$3</c:f>
                <c:numCache>
                  <c:formatCode>General</c:formatCode>
                  <c:ptCount val="2"/>
                  <c:pt idx="0">
                    <c:v>10.67</c:v>
                  </c:pt>
                  <c:pt idx="1">
                    <c:v>7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78.540000000000006</c:v>
                </c:pt>
                <c:pt idx="1">
                  <c:v>78.54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49-7C46-A070-92FE41EBD6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874448"/>
        <c:axId val="-2138911360"/>
      </c:barChart>
      <c:catAx>
        <c:axId val="-2138874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spc="-15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911360"/>
        <c:crosses val="autoZero"/>
        <c:auto val="1"/>
        <c:lblAlgn val="ctr"/>
        <c:lblOffset val="100"/>
        <c:noMultiLvlLbl val="0"/>
      </c:catAx>
      <c:valAx>
        <c:axId val="-213891136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87444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tra-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1"/>
            <c:plus>
              <c:numRef>
                <c:f>Sheet1!$E$2:$E$3</c:f>
                <c:numCache>
                  <c:formatCode>General</c:formatCode>
                  <c:ptCount val="2"/>
                  <c:pt idx="0">
                    <c:v>49.75</c:v>
                  </c:pt>
                  <c:pt idx="1">
                    <c:v>42.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238.3</c:v>
                </c:pt>
                <c:pt idx="1">
                  <c:v>219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30-7646-8CF3-CC94181039C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psi-</c:v>
                </c:pt>
              </c:strCache>
            </c:strRef>
          </c:tx>
          <c:spPr>
            <a:solidFill>
              <a:srgbClr val="E63A3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7679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8930-7646-8CF3-CC94181039CA}"/>
              </c:ext>
            </c:extLst>
          </c:dPt>
          <c:errBars>
            <c:errBarType val="plus"/>
            <c:errValType val="cust"/>
            <c:noEndCap val="1"/>
            <c:plus>
              <c:numRef>
                <c:f>Sheet1!$F$2:$F$3</c:f>
                <c:numCache>
                  <c:formatCode>General</c:formatCode>
                  <c:ptCount val="2"/>
                  <c:pt idx="0">
                    <c:v>27.76</c:v>
                  </c:pt>
                  <c:pt idx="1">
                    <c:v>13.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Cent.</c:v>
                </c:pt>
                <c:pt idx="1">
                  <c:v>Cent.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192.54</c:v>
                </c:pt>
                <c:pt idx="1">
                  <c:v>166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930-7646-8CF3-CC94181039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874448"/>
        <c:axId val="-2138911360"/>
      </c:barChart>
      <c:catAx>
        <c:axId val="-2138874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spc="-15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911360"/>
        <c:crosses val="autoZero"/>
        <c:auto val="1"/>
        <c:lblAlgn val="ctr"/>
        <c:lblOffset val="100"/>
        <c:noMultiLvlLbl val="0"/>
      </c:catAx>
      <c:valAx>
        <c:axId val="-2138911360"/>
        <c:scaling>
          <c:orientation val="minMax"/>
          <c:max val="4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-213887444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5320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67249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35721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65563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88019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15535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7413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92442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78738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70715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5153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D320A-6500-EC45-9D57-E8575BA69424}" type="datetimeFigureOut">
              <a:rPr lang="en-JP" smtClean="0"/>
              <a:t>2024/04/27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2A349-C828-B940-B2BE-7D184404796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25096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3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at with surgery tools&#10;&#10;Description automatically generated with medium confidence">
            <a:extLst>
              <a:ext uri="{FF2B5EF4-FFF2-40B4-BE49-F238E27FC236}">
                <a16:creationId xmlns:a16="http://schemas.microsoft.com/office/drawing/2014/main" id="{1F7B7F87-E3E1-26D8-5A9C-DDD34CC0C8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857" y="866623"/>
            <a:ext cx="6224286" cy="464900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5C334E5-DE1B-8673-BDC6-E0DA21796474}"/>
              </a:ext>
            </a:extLst>
          </p:cNvPr>
          <p:cNvSpPr txBox="1"/>
          <p:nvPr/>
        </p:nvSpPr>
        <p:spPr>
          <a:xfrm>
            <a:off x="316857" y="5517709"/>
            <a:ext cx="6218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ailed image of the head of the experimental setup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D2E663C-1616-8CE1-5CAE-591104C3C983}"/>
              </a:ext>
            </a:extLst>
          </p:cNvPr>
          <p:cNvSpPr txBox="1"/>
          <p:nvPr/>
        </p:nvSpPr>
        <p:spPr>
          <a:xfrm>
            <a:off x="4902099" y="3446244"/>
            <a:ext cx="1632948" cy="369332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JP" dirty="0"/>
              <a:t>Cranial window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A03A86B-CA6E-CFC0-CFE0-A15B4FDE3CC4}"/>
              </a:ext>
            </a:extLst>
          </p:cNvPr>
          <p:cNvSpPr txBox="1"/>
          <p:nvPr/>
        </p:nvSpPr>
        <p:spPr>
          <a:xfrm>
            <a:off x="4751313" y="2422026"/>
            <a:ext cx="1056700" cy="369332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JP" dirty="0"/>
              <a:t>urr hol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FD0866-B974-A767-5125-FE7FAA665F96}"/>
              </a:ext>
            </a:extLst>
          </p:cNvPr>
          <p:cNvSpPr txBox="1"/>
          <p:nvPr/>
        </p:nvSpPr>
        <p:spPr>
          <a:xfrm>
            <a:off x="378869" y="2378595"/>
            <a:ext cx="2388795" cy="369332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US" dirty="0"/>
              <a:t>S</a:t>
            </a:r>
            <a:r>
              <a:rPr lang="en-JP" dirty="0"/>
              <a:t>aline perfusion need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D083A7-6A19-F2F4-0198-7F8765FA2B91}"/>
              </a:ext>
            </a:extLst>
          </p:cNvPr>
          <p:cNvSpPr txBox="1"/>
          <p:nvPr/>
        </p:nvSpPr>
        <p:spPr>
          <a:xfrm>
            <a:off x="316857" y="3890567"/>
            <a:ext cx="2839816" cy="369332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JP" dirty="0"/>
              <a:t>ECoG&amp;Tempeprature sensor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57D0004-2D24-E3B1-E3AB-E657995DB7C8}"/>
              </a:ext>
            </a:extLst>
          </p:cNvPr>
          <p:cNvCxnSpPr/>
          <p:nvPr/>
        </p:nvCxnSpPr>
        <p:spPr>
          <a:xfrm flipH="1">
            <a:off x="4038602" y="2606692"/>
            <a:ext cx="712713" cy="407260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90A23FD-F900-7104-1D1A-684D0CD9AE63}"/>
              </a:ext>
            </a:extLst>
          </p:cNvPr>
          <p:cNvCxnSpPr>
            <a:cxnSpLocks/>
            <a:stCxn id="4" idx="1"/>
          </p:cNvCxnSpPr>
          <p:nvPr/>
        </p:nvCxnSpPr>
        <p:spPr>
          <a:xfrm flipH="1">
            <a:off x="4184906" y="3630910"/>
            <a:ext cx="717195" cy="0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99E3EAB-B0F6-823C-83DD-1659408DEF9C}"/>
              </a:ext>
            </a:extLst>
          </p:cNvPr>
          <p:cNvCxnSpPr>
            <a:cxnSpLocks/>
            <a:stCxn id="11" idx="3"/>
          </p:cNvCxnSpPr>
          <p:nvPr/>
        </p:nvCxnSpPr>
        <p:spPr>
          <a:xfrm flipV="1">
            <a:off x="3156675" y="3740585"/>
            <a:ext cx="272327" cy="334648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E1A442DC-994A-BAEB-6177-8AE36B8BFBD6}"/>
              </a:ext>
            </a:extLst>
          </p:cNvPr>
          <p:cNvCxnSpPr>
            <a:cxnSpLocks/>
            <a:stCxn id="8" idx="3"/>
          </p:cNvCxnSpPr>
          <p:nvPr/>
        </p:nvCxnSpPr>
        <p:spPr>
          <a:xfrm>
            <a:off x="2767662" y="2563263"/>
            <a:ext cx="214238" cy="43431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F991813-3A58-8FFC-D9CF-1F1752BB1264}"/>
              </a:ext>
            </a:extLst>
          </p:cNvPr>
          <p:cNvCxnSpPr>
            <a:cxnSpLocks/>
            <a:stCxn id="11" idx="3"/>
          </p:cNvCxnSpPr>
          <p:nvPr/>
        </p:nvCxnSpPr>
        <p:spPr>
          <a:xfrm flipV="1">
            <a:off x="3156675" y="3501634"/>
            <a:ext cx="211367" cy="573601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B0FB0EB-0CA7-1A1A-33E8-C92735605103}"/>
              </a:ext>
            </a:extLst>
          </p:cNvPr>
          <p:cNvSpPr txBox="1"/>
          <p:nvPr/>
        </p:nvSpPr>
        <p:spPr>
          <a:xfrm>
            <a:off x="507378" y="984369"/>
            <a:ext cx="3271665" cy="646331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US" dirty="0"/>
              <a:t>Reference electrode</a:t>
            </a:r>
          </a:p>
          <a:p>
            <a:r>
              <a:rPr lang="en-US" dirty="0"/>
              <a:t> (Covered with moisture cotton)</a:t>
            </a:r>
            <a:endParaRPr lang="en-JP" dirty="0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568F083-FB0E-79B4-920E-AE9E563A17A5}"/>
              </a:ext>
            </a:extLst>
          </p:cNvPr>
          <p:cNvCxnSpPr>
            <a:cxnSpLocks/>
            <a:stCxn id="26" idx="2"/>
          </p:cNvCxnSpPr>
          <p:nvPr/>
        </p:nvCxnSpPr>
        <p:spPr>
          <a:xfrm>
            <a:off x="2143209" y="1630698"/>
            <a:ext cx="1471066" cy="975994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628DF45-F718-F262-8049-811681D09D93}"/>
              </a:ext>
            </a:extLst>
          </p:cNvPr>
          <p:cNvSpPr txBox="1"/>
          <p:nvPr/>
        </p:nvSpPr>
        <p:spPr>
          <a:xfrm>
            <a:off x="4991541" y="4337384"/>
            <a:ext cx="962443" cy="369332"/>
          </a:xfrm>
          <a:prstGeom prst="rect">
            <a:avLst/>
          </a:prstGeom>
          <a:solidFill>
            <a:schemeClr val="bg1"/>
          </a:solidFill>
          <a:effectLst>
            <a:softEdge rad="101600"/>
          </a:effectLst>
        </p:spPr>
        <p:txBody>
          <a:bodyPr wrap="none" rtlCol="0">
            <a:spAutoFit/>
          </a:bodyPr>
          <a:lstStyle/>
          <a:p>
            <a:r>
              <a:rPr lang="en-JP" dirty="0"/>
              <a:t>parafilm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FB5CF78E-55BA-D3A5-50F4-08255A5217CF}"/>
              </a:ext>
            </a:extLst>
          </p:cNvPr>
          <p:cNvCxnSpPr>
            <a:cxnSpLocks/>
            <a:stCxn id="35" idx="1"/>
          </p:cNvCxnSpPr>
          <p:nvPr/>
        </p:nvCxnSpPr>
        <p:spPr>
          <a:xfrm flipH="1" flipV="1">
            <a:off x="4751313" y="4271405"/>
            <a:ext cx="240226" cy="250647"/>
          </a:xfrm>
          <a:prstGeom prst="straightConnector1">
            <a:avLst/>
          </a:prstGeom>
          <a:ln>
            <a:tailEnd type="triangle"/>
          </a:ln>
          <a:effectLst>
            <a:glow rad="38100">
              <a:schemeClr val="bg1">
                <a:alpha val="50000"/>
              </a:schemeClr>
            </a:glow>
          </a:effectLst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Left-Right Arrow 39">
            <a:extLst>
              <a:ext uri="{FF2B5EF4-FFF2-40B4-BE49-F238E27FC236}">
                <a16:creationId xmlns:a16="http://schemas.microsoft.com/office/drawing/2014/main" id="{A0D81AC7-7A9F-E994-C04D-1711A58FAFCD}"/>
              </a:ext>
            </a:extLst>
          </p:cNvPr>
          <p:cNvSpPr/>
          <p:nvPr/>
        </p:nvSpPr>
        <p:spPr>
          <a:xfrm rot="16200000">
            <a:off x="5762614" y="1508503"/>
            <a:ext cx="767980" cy="184939"/>
          </a:xfrm>
          <a:prstGeom prst="left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6012" tIns="48006" rIns="96012" bIns="48006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FBC65D1-8F51-5AD3-DE3C-9A9023A2A95E}"/>
              </a:ext>
            </a:extLst>
          </p:cNvPr>
          <p:cNvSpPr txBox="1"/>
          <p:nvPr/>
        </p:nvSpPr>
        <p:spPr>
          <a:xfrm>
            <a:off x="5977327" y="1986002"/>
            <a:ext cx="33855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7927C97-7BE7-2ED1-EAE3-EDD4D366BDB9}"/>
              </a:ext>
            </a:extLst>
          </p:cNvPr>
          <p:cNvSpPr txBox="1"/>
          <p:nvPr/>
        </p:nvSpPr>
        <p:spPr>
          <a:xfrm>
            <a:off x="5977327" y="866156"/>
            <a:ext cx="33855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27667453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C8B9740-260A-2870-20D9-C335390535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03505040"/>
              </p:ext>
            </p:extLst>
          </p:nvPr>
        </p:nvGraphicFramePr>
        <p:xfrm>
          <a:off x="664742" y="2314832"/>
          <a:ext cx="2872067" cy="1835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8A9C67E-FAFF-B39C-9050-188E79D6928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18398330"/>
              </p:ext>
            </p:extLst>
          </p:nvPr>
        </p:nvGraphicFramePr>
        <p:xfrm>
          <a:off x="664742" y="4152004"/>
          <a:ext cx="2872067" cy="1835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EDD8D3D-268B-F21B-FCB8-A97B84654E6A}"/>
              </a:ext>
            </a:extLst>
          </p:cNvPr>
          <p:cNvSpPr txBox="1"/>
          <p:nvPr/>
        </p:nvSpPr>
        <p:spPr>
          <a:xfrm>
            <a:off x="287563" y="2406351"/>
            <a:ext cx="430887" cy="126834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Tubulin [%]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787A45-5E30-33F2-EF02-8FAFB09D2A94}"/>
              </a:ext>
            </a:extLst>
          </p:cNvPr>
          <p:cNvSpPr txBox="1"/>
          <p:nvPr/>
        </p:nvSpPr>
        <p:spPr>
          <a:xfrm>
            <a:off x="302721" y="3897259"/>
            <a:ext cx="430887" cy="194083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eNOS/Tubulin [%]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D2A976-1BAB-FC7D-8888-260FE32BDFC5}"/>
              </a:ext>
            </a:extLst>
          </p:cNvPr>
          <p:cNvSpPr txBox="1"/>
          <p:nvPr/>
        </p:nvSpPr>
        <p:spPr>
          <a:xfrm>
            <a:off x="2343142" y="5950561"/>
            <a:ext cx="2450394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r"/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ïve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ja-JP" altLang="en-US" sz="1600" b="1">
                <a:solidFill>
                  <a:srgbClr val="E63A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ja-JP" altLang="en-US" sz="1600" b="1">
                <a:solidFill>
                  <a:srgbClr val="47679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13174BF-BCDE-D270-5127-0E350305A36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72990650"/>
              </p:ext>
            </p:extLst>
          </p:nvPr>
        </p:nvGraphicFramePr>
        <p:xfrm>
          <a:off x="3613707" y="2314832"/>
          <a:ext cx="2872067" cy="1835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BBB38FC-C2D4-54E7-7AF8-B68064208AC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43828509"/>
              </p:ext>
            </p:extLst>
          </p:nvPr>
        </p:nvGraphicFramePr>
        <p:xfrm>
          <a:off x="3591990" y="4158498"/>
          <a:ext cx="2872067" cy="1835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AA51E33-5FBC-E71D-5956-4346F6C78320}"/>
              </a:ext>
            </a:extLst>
          </p:cNvPr>
          <p:cNvSpPr txBox="1"/>
          <p:nvPr/>
        </p:nvSpPr>
        <p:spPr>
          <a:xfrm flipH="1">
            <a:off x="5028023" y="3974595"/>
            <a:ext cx="1582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600" spc="-150" dirty="0">
                <a:latin typeface="Arial" panose="020B0604020202020204" pitchFamily="34" charset="0"/>
                <a:cs typeface="Arial" panose="020B0604020202020204" pitchFamily="34" charset="0"/>
              </a:rPr>
              <a:t>(Compensated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3B710C-90C6-11BD-0421-608A8C37B1C6}"/>
              </a:ext>
            </a:extLst>
          </p:cNvPr>
          <p:cNvSpPr txBox="1"/>
          <p:nvPr/>
        </p:nvSpPr>
        <p:spPr>
          <a:xfrm flipH="1">
            <a:off x="5001017" y="5818123"/>
            <a:ext cx="1582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sz="1600" spc="-150" dirty="0">
                <a:latin typeface="Arial" panose="020B0604020202020204" pitchFamily="34" charset="0"/>
                <a:cs typeface="Arial" panose="020B0604020202020204" pitchFamily="34" charset="0"/>
              </a:rPr>
              <a:t>(Compensated)</a:t>
            </a:r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3B64CBA9-DC40-9E90-164D-0E78DC5469E7}"/>
              </a:ext>
            </a:extLst>
          </p:cNvPr>
          <p:cNvSpPr/>
          <p:nvPr/>
        </p:nvSpPr>
        <p:spPr>
          <a:xfrm rot="5400000">
            <a:off x="2076525" y="2128096"/>
            <a:ext cx="191520" cy="1069278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916EA51-2C27-7EA9-224B-7696405D1469}"/>
              </a:ext>
            </a:extLst>
          </p:cNvPr>
          <p:cNvSpPr/>
          <p:nvPr/>
        </p:nvSpPr>
        <p:spPr>
          <a:xfrm>
            <a:off x="2019253" y="2429305"/>
            <a:ext cx="35649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pc="-300" dirty="0">
                <a:effectLst>
                  <a:glow rad="635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pc="-150" dirty="0">
                <a:effectLst>
                  <a:glow rad="635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7EF9AF56-014D-F540-1884-5D89E8FD62B2}"/>
              </a:ext>
            </a:extLst>
          </p:cNvPr>
          <p:cNvSpPr/>
          <p:nvPr/>
        </p:nvSpPr>
        <p:spPr>
          <a:xfrm rot="5400000">
            <a:off x="2384514" y="1905513"/>
            <a:ext cx="191520" cy="1069278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2B0B2A9-9000-6C5E-A3C4-1447ED5C6704}"/>
              </a:ext>
            </a:extLst>
          </p:cNvPr>
          <p:cNvSpPr/>
          <p:nvPr/>
        </p:nvSpPr>
        <p:spPr>
          <a:xfrm>
            <a:off x="2281416" y="2185082"/>
            <a:ext cx="35649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pc="-300" dirty="0">
                <a:effectLst>
                  <a:glow rad="635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pc="-150" dirty="0">
                <a:effectLst>
                  <a:glow rad="635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371DC8C-AB74-6AB9-05F0-823DCF976F8D}"/>
              </a:ext>
            </a:extLst>
          </p:cNvPr>
          <p:cNvSpPr txBox="1"/>
          <p:nvPr/>
        </p:nvSpPr>
        <p:spPr>
          <a:xfrm>
            <a:off x="32083" y="6252880"/>
            <a:ext cx="59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70BB70-A4FA-B0FB-8A47-16B4007E9666}"/>
              </a:ext>
            </a:extLst>
          </p:cNvPr>
          <p:cNvSpPr txBox="1"/>
          <p:nvPr/>
        </p:nvSpPr>
        <p:spPr>
          <a:xfrm>
            <a:off x="39952" y="2403751"/>
            <a:ext cx="59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CA5860A-71B3-2255-A56B-02E0468F1CD1}"/>
              </a:ext>
            </a:extLst>
          </p:cNvPr>
          <p:cNvSpPr txBox="1"/>
          <p:nvPr/>
        </p:nvSpPr>
        <p:spPr>
          <a:xfrm>
            <a:off x="39952" y="3979660"/>
            <a:ext cx="59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39E59F-2D65-185D-286C-EB3FAF7F08AE}"/>
              </a:ext>
            </a:extLst>
          </p:cNvPr>
          <p:cNvSpPr txBox="1"/>
          <p:nvPr/>
        </p:nvSpPr>
        <p:spPr>
          <a:xfrm>
            <a:off x="32082" y="195828"/>
            <a:ext cx="59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5E817C5D-49F3-9C58-2D39-DD715B2BD1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4021" y="6450894"/>
            <a:ext cx="5875512" cy="298495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5411DF7E-DDE5-F146-F067-42FDB9C8BA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81215" y="683257"/>
            <a:ext cx="4279355" cy="149830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B5B4144-E062-37E0-4623-7CA059C5A6C9}"/>
              </a:ext>
            </a:extLst>
          </p:cNvPr>
          <p:cNvSpPr txBox="1"/>
          <p:nvPr/>
        </p:nvSpPr>
        <p:spPr>
          <a:xfrm>
            <a:off x="1481491" y="364586"/>
            <a:ext cx="77284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E617A28-F1E0-E830-9915-EFAA7FE2358C}"/>
              </a:ext>
            </a:extLst>
          </p:cNvPr>
          <p:cNvSpPr txBox="1"/>
          <p:nvPr/>
        </p:nvSpPr>
        <p:spPr>
          <a:xfrm>
            <a:off x="3515293" y="364586"/>
            <a:ext cx="77284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naiv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CC3B886-3C6C-F0B6-2CB1-76AA86B90C46}"/>
              </a:ext>
            </a:extLst>
          </p:cNvPr>
          <p:cNvSpPr txBox="1"/>
          <p:nvPr/>
        </p:nvSpPr>
        <p:spPr>
          <a:xfrm>
            <a:off x="2360525" y="364586"/>
            <a:ext cx="1119573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11C5BB2-E345-6FDD-025F-FC2CB82AAD23}"/>
              </a:ext>
            </a:extLst>
          </p:cNvPr>
          <p:cNvSpPr txBox="1"/>
          <p:nvPr/>
        </p:nvSpPr>
        <p:spPr>
          <a:xfrm>
            <a:off x="4384963" y="364586"/>
            <a:ext cx="1119573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0FC27E-5BCD-702A-4A9D-129728F36A57}"/>
              </a:ext>
            </a:extLst>
          </p:cNvPr>
          <p:cNvSpPr txBox="1"/>
          <p:nvPr/>
        </p:nvSpPr>
        <p:spPr>
          <a:xfrm>
            <a:off x="4027724" y="107649"/>
            <a:ext cx="77284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B28461-27B9-2F7A-BDF7-63F0D6B194FA}"/>
              </a:ext>
            </a:extLst>
          </p:cNvPr>
          <p:cNvSpPr txBox="1"/>
          <p:nvPr/>
        </p:nvSpPr>
        <p:spPr>
          <a:xfrm>
            <a:off x="2023236" y="107649"/>
            <a:ext cx="77284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CE5E7F6-9AB8-305E-314F-0923A9BAFF39}"/>
              </a:ext>
            </a:extLst>
          </p:cNvPr>
          <p:cNvSpPr txBox="1"/>
          <p:nvPr/>
        </p:nvSpPr>
        <p:spPr>
          <a:xfrm>
            <a:off x="404021" y="1796523"/>
            <a:ext cx="92653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CBA685D-F0AE-40AE-47FE-44ECBD8C1F66}"/>
              </a:ext>
            </a:extLst>
          </p:cNvPr>
          <p:cNvSpPr txBox="1"/>
          <p:nvPr/>
        </p:nvSpPr>
        <p:spPr>
          <a:xfrm>
            <a:off x="404021" y="1263132"/>
            <a:ext cx="926538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eNO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2B63F6A-E6ED-206F-4FFB-30855C06356D}"/>
              </a:ext>
            </a:extLst>
          </p:cNvPr>
          <p:cNvSpPr txBox="1"/>
          <p:nvPr/>
        </p:nvSpPr>
        <p:spPr>
          <a:xfrm>
            <a:off x="323882" y="726572"/>
            <a:ext cx="1086817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JP" sz="1600" b="1" dirty="0">
                <a:latin typeface="Arial" panose="020B0604020202020204" pitchFamily="34" charset="0"/>
                <a:cs typeface="Arial" panose="020B0604020202020204" pitchFamily="34" charset="0"/>
              </a:rPr>
              <a:t>-eNO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D93219B-BF37-D041-E362-085CAFE0FC71}"/>
              </a:ext>
            </a:extLst>
          </p:cNvPr>
          <p:cNvSpPr txBox="1"/>
          <p:nvPr/>
        </p:nvSpPr>
        <p:spPr>
          <a:xfrm>
            <a:off x="5491993" y="1797423"/>
            <a:ext cx="1217212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◀︎ 52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JP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0BB9E1E-A01E-593C-F1EA-3B438A55F151}"/>
              </a:ext>
            </a:extLst>
          </p:cNvPr>
          <p:cNvSpPr txBox="1"/>
          <p:nvPr/>
        </p:nvSpPr>
        <p:spPr>
          <a:xfrm>
            <a:off x="5491993" y="1264032"/>
            <a:ext cx="1217213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◀︎ 140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JP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93CA154-457F-FE79-C7B3-8F821DD55BBF}"/>
              </a:ext>
            </a:extLst>
          </p:cNvPr>
          <p:cNvSpPr txBox="1"/>
          <p:nvPr/>
        </p:nvSpPr>
        <p:spPr>
          <a:xfrm>
            <a:off x="5491993" y="727472"/>
            <a:ext cx="1217213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◀︎ 140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JP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A9FF442-A880-B9C4-1B84-F686EE0B1696}"/>
              </a:ext>
            </a:extLst>
          </p:cNvPr>
          <p:cNvSpPr txBox="1"/>
          <p:nvPr/>
        </p:nvSpPr>
        <p:spPr>
          <a:xfrm>
            <a:off x="-1688" y="9481764"/>
            <a:ext cx="68596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 of cooling on tubulin and its correction.</a:t>
            </a:r>
          </a:p>
        </p:txBody>
      </p:sp>
    </p:spTree>
    <p:extLst>
      <p:ext uri="{BB962C8B-B14F-4D97-AF65-F5344CB8AC3E}">
        <p14:creationId xmlns:p14="http://schemas.microsoft.com/office/powerpoint/2010/main" val="1619729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C0D13-09A1-8FF9-06D4-D22FFBFC33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254833"/>
            <a:ext cx="5915025" cy="8667447"/>
          </a:xfrm>
        </p:spPr>
        <p:txBody>
          <a:bodyPr/>
          <a:lstStyle/>
          <a:p>
            <a:pPr marL="0" indent="0"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Superficial cortical layers were dissected and analyzed by Western blot. Molecular masses of standards are indicated in kDa on the right. (B) Effect of cooling on β- tubulin. No correction (left) and correction (right) for cooling-induced decrease in β-tubulin. (C) Total endothelial nitric oxide synthase (eNOS) was normalized to total β-tubulin. No correction (left) and correction (right) for cooling-induced decrease in β-tubulin. (D) Calculate correction factors for tubulin expression response to cooling based on Western blot results. The calculation process is shown by proceeding from left to right. Top half: The expression ratio for the right hemisphere (naive) was calculated by dividing the average tubulin expression under cooling conditions by the average expression under uncooled conditions, resulting in a ratio of 0.6845. Lower half: The expression ratio for the left hemisphere was also calculated using the same comparative method, resulting in a ratio of 0.6323. * P &lt; 0.05, Error bars indicate SEM., Cent. = Central.</a:t>
            </a:r>
            <a:r>
              <a:rPr lang="en-JP" dirty="0">
                <a:effectLst/>
              </a:rPr>
              <a:t> </a:t>
            </a:r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7889954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4951261-58CF-E698-F264-9477B3AF8ECB}"/>
              </a:ext>
            </a:extLst>
          </p:cNvPr>
          <p:cNvSpPr txBox="1"/>
          <p:nvPr/>
        </p:nvSpPr>
        <p:spPr>
          <a:xfrm>
            <a:off x="50514" y="4070457"/>
            <a:ext cx="6860892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emporal Profiles of Brain Temperature and DC-Shift During Focal Brain Cooling (FBC).</a:t>
            </a:r>
          </a:p>
          <a:p>
            <a:pPr algn="just"/>
            <a:endParaRPr 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) Brain temperature (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before and after the onset of FBC. The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apidly declines following the initiation of cooling, demonstrating a clear transition from normal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o the targeted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nditions over 300 seconds. The moment of cooling initiation is marked at zero on the horizontal axis. B) The rate of FBC, calculated from the differential of the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ver time. The steepest decline is observed within the first minute, indicating the most rapid cooling phase. C) An expanded view of the DC-ECoG. Notable shifts in the DC-ECoG signal align with changes in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rT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60FFF934-9A05-5CAD-5141-07527FAA9349}"/>
              </a:ext>
            </a:extLst>
          </p:cNvPr>
          <p:cNvGrpSpPr/>
          <p:nvPr/>
        </p:nvGrpSpPr>
        <p:grpSpPr>
          <a:xfrm>
            <a:off x="0" y="10811"/>
            <a:ext cx="6858000" cy="3914775"/>
            <a:chOff x="0" y="10811"/>
            <a:chExt cx="6858000" cy="3914775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19B805B-FDE7-3A68-B7B9-CBAC6796D695}"/>
                </a:ext>
              </a:extLst>
            </p:cNvPr>
            <p:cNvGrpSpPr/>
            <p:nvPr/>
          </p:nvGrpSpPr>
          <p:grpSpPr>
            <a:xfrm>
              <a:off x="0" y="10811"/>
              <a:ext cx="6858000" cy="3914775"/>
              <a:chOff x="0" y="10811"/>
              <a:chExt cx="6858000" cy="3914775"/>
            </a:xfrm>
          </p:grpSpPr>
          <p:pic>
            <p:nvPicPr>
              <p:cNvPr id="29" name="Graphic 28">
                <a:extLst>
                  <a:ext uri="{FF2B5EF4-FFF2-40B4-BE49-F238E27FC236}">
                    <a16:creationId xmlns:a16="http://schemas.microsoft.com/office/drawing/2014/main" id="{45690761-9847-2EE9-8A25-4E81B7B4D9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0" y="10811"/>
                <a:ext cx="6858000" cy="3914775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4C38EB4-6C74-6B22-B4A0-B52EA9A61550}"/>
                  </a:ext>
                </a:extLst>
              </p:cNvPr>
              <p:cNvSpPr txBox="1"/>
              <p:nvPr/>
            </p:nvSpPr>
            <p:spPr>
              <a:xfrm>
                <a:off x="1531826" y="3439222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7A8F49B-C7E6-2ECB-B437-6E5A3807EED7}"/>
                  </a:ext>
                </a:extLst>
              </p:cNvPr>
              <p:cNvSpPr txBox="1"/>
              <p:nvPr/>
            </p:nvSpPr>
            <p:spPr>
              <a:xfrm>
                <a:off x="2269854" y="343922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DEF58C5-B065-DF17-99F8-317F09E5503E}"/>
                  </a:ext>
                </a:extLst>
              </p:cNvPr>
              <p:cNvSpPr txBox="1"/>
              <p:nvPr/>
            </p:nvSpPr>
            <p:spPr>
              <a:xfrm>
                <a:off x="2999302" y="3439222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735EBB6-5142-FE4C-4880-F1916A1A348B}"/>
                  </a:ext>
                </a:extLst>
              </p:cNvPr>
              <p:cNvSpPr txBox="1"/>
              <p:nvPr/>
            </p:nvSpPr>
            <p:spPr>
              <a:xfrm>
                <a:off x="3766773" y="3439222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888BA194-BFC5-2D4C-E902-6856B3189BB6}"/>
                  </a:ext>
                </a:extLst>
              </p:cNvPr>
              <p:cNvSpPr txBox="1"/>
              <p:nvPr/>
            </p:nvSpPr>
            <p:spPr>
              <a:xfrm>
                <a:off x="4517579" y="3439222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4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CE56CC5-FF55-03B1-9381-CB9F01A02702}"/>
                  </a:ext>
                </a:extLst>
              </p:cNvPr>
              <p:cNvSpPr txBox="1"/>
              <p:nvPr/>
            </p:nvSpPr>
            <p:spPr>
              <a:xfrm>
                <a:off x="5282564" y="3439222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7001B79-2D8F-F52D-F258-568DDF0D5297}"/>
                  </a:ext>
                </a:extLst>
              </p:cNvPr>
              <p:cNvSpPr txBox="1"/>
              <p:nvPr/>
            </p:nvSpPr>
            <p:spPr>
              <a:xfrm>
                <a:off x="6038507" y="3439222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60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59F315E9-2E77-3D07-E3F5-7948C9E3167F}"/>
                  </a:ext>
                </a:extLst>
              </p:cNvPr>
              <p:cNvSpPr txBox="1"/>
              <p:nvPr/>
            </p:nvSpPr>
            <p:spPr>
              <a:xfrm>
                <a:off x="102848" y="211424"/>
                <a:ext cx="3882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dirty="0"/>
                  <a:t>A)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55EBDAE1-00AC-5FE0-F65F-4E1E048A21B6}"/>
                  </a:ext>
                </a:extLst>
              </p:cNvPr>
              <p:cNvSpPr txBox="1"/>
              <p:nvPr/>
            </p:nvSpPr>
            <p:spPr>
              <a:xfrm>
                <a:off x="102848" y="1323553"/>
                <a:ext cx="3802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dirty="0"/>
                  <a:t>B)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A64DBE4F-FCC2-ECE2-0FF1-75610305D59A}"/>
                  </a:ext>
                </a:extLst>
              </p:cNvPr>
              <p:cNvSpPr txBox="1"/>
              <p:nvPr/>
            </p:nvSpPr>
            <p:spPr>
              <a:xfrm>
                <a:off x="102848" y="2430601"/>
                <a:ext cx="3786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dirty="0"/>
                  <a:t>C)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A5370E-AE47-DCB1-2037-B6749C2B440F}"/>
                </a:ext>
              </a:extLst>
            </p:cNvPr>
            <p:cNvSpPr txBox="1"/>
            <p:nvPr/>
          </p:nvSpPr>
          <p:spPr>
            <a:xfrm>
              <a:off x="5940938" y="3563688"/>
              <a:ext cx="4555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[s</a:t>
              </a:r>
              <a:r>
                <a:rPr lang="en-JP" sz="1100" dirty="0"/>
                <a:t>ec]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03977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58</TotalTime>
  <Words>436</Words>
  <Application>Microsoft Macintosh PowerPoint</Application>
  <PresentationFormat>A4 Paper (210x297 mm)</PresentationFormat>
  <Paragraphs>4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井上　貴雄</dc:creator>
  <cp:lastModifiedBy>井上　貴雄</cp:lastModifiedBy>
  <cp:revision>18</cp:revision>
  <dcterms:created xsi:type="dcterms:W3CDTF">2023-10-27T00:44:03Z</dcterms:created>
  <dcterms:modified xsi:type="dcterms:W3CDTF">2024-04-27T07:47:28Z</dcterms:modified>
</cp:coreProperties>
</file>